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B5CB46-BFC9-49C1-97E7-CFAEE830B0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622B79-A7B5-4F1D-AD57-5D1ACF846A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AEE56-E5E9-4B0B-9367-F4AA682765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5661A-F065-401C-8DDA-DB17175926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DB61B7-D589-40D8-9CEA-EDBB64F642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6DEDF-9544-4080-B640-60D22D8456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27C257-79FE-473B-8583-0CA7CE997A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465906-BCB3-483D-A3BE-751681A84F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7AE9F6-7B11-4BBD-B249-777B3392EE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C1F825-3896-49CF-9BEC-DBED4CBAFC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487CC3-69C6-45EA-8B4D-7234DF7454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24090-61D0-412E-8E3B-3BCF3AE28F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50C652-BD78-4A23-BBD2-0D4990A6AA0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ounded Rectangle 64"/>
          <p:cNvSpPr/>
          <p:nvPr/>
        </p:nvSpPr>
        <p:spPr>
          <a:xfrm>
            <a:off x="609480" y="152280"/>
            <a:ext cx="3353040" cy="6553440"/>
          </a:xfrm>
          <a:custGeom>
            <a:avLst/>
            <a:gdLst>
              <a:gd name="textAreaLeft" fmla="*/ 45360 w 3353040"/>
              <a:gd name="textAreaRight" fmla="*/ 3307680 w 3353040"/>
              <a:gd name="textAreaTop" fmla="*/ 45360 h 6553440"/>
              <a:gd name="textAreaBottom" fmla="*/ 6508080 h 6553440"/>
            </a:gdLst>
            <a:ahLst/>
            <a:rect l="textAreaLeft" t="textAreaTop" r="textAreaRight" b="textAreaBottom"/>
            <a:pathLst>
              <a:path w="21600" h="42214">
                <a:moveTo>
                  <a:pt x="1004" y="0"/>
                </a:moveTo>
                <a:arcTo wR="1004" hR="1004" stAng="16200000" swAng="-5400000"/>
                <a:lnTo>
                  <a:pt x="0" y="41210"/>
                </a:lnTo>
                <a:arcTo wR="1004" hR="1004" stAng="10800000" swAng="-5400000"/>
                <a:lnTo>
                  <a:pt x="20596" y="42214"/>
                </a:lnTo>
                <a:arcTo wR="1004" hR="1004" stAng="5400000" swAng="-5400000"/>
                <a:lnTo>
                  <a:pt x="21600" y="1004"/>
                </a:lnTo>
                <a:arcTo wR="1004" hR="1004" stAng="0" swAng="-5400000"/>
                <a:close/>
              </a:path>
            </a:pathLst>
          </a:custGeom>
          <a:solidFill>
            <a:srgbClr val="f2f2f2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B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ounded Rectangle 63"/>
          <p:cNvSpPr/>
          <p:nvPr/>
        </p:nvSpPr>
        <p:spPr>
          <a:xfrm>
            <a:off x="4724280" y="152280"/>
            <a:ext cx="3962520" cy="5943600"/>
          </a:xfrm>
          <a:custGeom>
            <a:avLst/>
            <a:gdLst>
              <a:gd name="textAreaLeft" fmla="*/ 53640 w 3962520"/>
              <a:gd name="textAreaRight" fmla="*/ 3908880 w 3962520"/>
              <a:gd name="textAreaTop" fmla="*/ 53640 h 5943600"/>
              <a:gd name="textAreaBottom" fmla="*/ 5889960 h 5943600"/>
            </a:gdLst>
            <a:ahLst/>
            <a:rect l="textAreaLeft" t="textAreaTop" r="textAreaRight" b="textAreaBottom"/>
            <a:pathLst>
              <a:path w="21600" h="32398">
                <a:moveTo>
                  <a:pt x="1004" y="0"/>
                </a:moveTo>
                <a:arcTo wR="1004" hR="1004" stAng="16200000" swAng="-5400000"/>
                <a:lnTo>
                  <a:pt x="0" y="31394"/>
                </a:lnTo>
                <a:arcTo wR="1004" hR="1004" stAng="10800000" swAng="-5400000"/>
                <a:lnTo>
                  <a:pt x="20596" y="32398"/>
                </a:lnTo>
                <a:arcTo wR="1004" hR="1004" stAng="5400000" swAng="-5400000"/>
                <a:lnTo>
                  <a:pt x="21600" y="1004"/>
                </a:lnTo>
                <a:arcTo wR="1004" hR="1004" stAng="0" swAng="-5400000"/>
                <a:close/>
              </a:path>
            </a:pathLst>
          </a:custGeom>
          <a:solidFill>
            <a:srgbClr val="f2f2f2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ounded Rectangle 3"/>
          <p:cNvSpPr/>
          <p:nvPr/>
        </p:nvSpPr>
        <p:spPr>
          <a:xfrm>
            <a:off x="1282680" y="900000"/>
            <a:ext cx="2070000" cy="68580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ffffff"/>
                </a:solidFill>
                <a:latin typeface="Calibri"/>
              </a:rPr>
              <a:t>Base Calling and Quality Check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ounded Rectangle 4"/>
          <p:cNvSpPr/>
          <p:nvPr/>
        </p:nvSpPr>
        <p:spPr>
          <a:xfrm>
            <a:off x="1638360" y="1928880"/>
            <a:ext cx="1523880" cy="1066680"/>
          </a:xfrm>
          <a:prstGeom prst="roundRect">
            <a:avLst>
              <a:gd name="adj" fmla="val 9046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ffffff"/>
                </a:solidFill>
                <a:latin typeface="Calibri"/>
              </a:rPr>
              <a:t>Mapping to Reference Genome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ounded Rectangle 6"/>
          <p:cNvSpPr/>
          <p:nvPr/>
        </p:nvSpPr>
        <p:spPr>
          <a:xfrm>
            <a:off x="1752480" y="3370320"/>
            <a:ext cx="1295640" cy="68580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ffffff"/>
                </a:solidFill>
                <a:latin typeface="Calibri"/>
              </a:rPr>
              <a:t>Variant Calling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ounded Rectangle 7"/>
          <p:cNvSpPr/>
          <p:nvPr/>
        </p:nvSpPr>
        <p:spPr>
          <a:xfrm>
            <a:off x="1752480" y="4406760"/>
            <a:ext cx="1295640" cy="68580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ffffff"/>
                </a:solidFill>
                <a:latin typeface="Calibri"/>
              </a:rPr>
              <a:t>Variant Annotation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ounded Rectangle 8"/>
          <p:cNvSpPr/>
          <p:nvPr/>
        </p:nvSpPr>
        <p:spPr>
          <a:xfrm>
            <a:off x="1752480" y="5410080"/>
            <a:ext cx="1295640" cy="68580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ffffff"/>
                </a:solidFill>
                <a:latin typeface="Calibri"/>
              </a:rPr>
              <a:t>Variant Filtration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8" name="Straight Arrow Connector 10"/>
          <p:cNvCxnSpPr/>
          <p:nvPr/>
        </p:nvCxnSpPr>
        <p:spPr>
          <a:xfrm>
            <a:off x="2400120" y="1600200"/>
            <a:ext cx="1080" cy="2800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49" name="Straight Arrow Connector 11"/>
          <p:cNvCxnSpPr/>
          <p:nvPr/>
        </p:nvCxnSpPr>
        <p:spPr>
          <a:xfrm>
            <a:off x="2400120" y="3041640"/>
            <a:ext cx="1080" cy="3117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50" name="Straight Arrow Connector 14"/>
          <p:cNvCxnSpPr>
            <a:stCxn id="45" idx="2"/>
            <a:endCxn id="46" idx="0"/>
          </p:cNvCxnSpPr>
          <p:nvPr/>
        </p:nvCxnSpPr>
        <p:spPr>
          <a:xfrm>
            <a:off x="2400120" y="4056120"/>
            <a:ext cx="360" cy="351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51" name="Straight Arrow Connector 17"/>
          <p:cNvCxnSpPr/>
          <p:nvPr/>
        </p:nvCxnSpPr>
        <p:spPr>
          <a:xfrm>
            <a:off x="2400120" y="5070240"/>
            <a:ext cx="1080" cy="33084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2" name="TextBox 45"/>
          <p:cNvSpPr/>
          <p:nvPr/>
        </p:nvSpPr>
        <p:spPr>
          <a:xfrm>
            <a:off x="749160" y="1609560"/>
            <a:ext cx="1067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Unaligned BA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46"/>
          <p:cNvSpPr/>
          <p:nvPr/>
        </p:nvSpPr>
        <p:spPr>
          <a:xfrm>
            <a:off x="749160" y="2952720"/>
            <a:ext cx="106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BA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47"/>
          <p:cNvSpPr/>
          <p:nvPr/>
        </p:nvSpPr>
        <p:spPr>
          <a:xfrm>
            <a:off x="749160" y="4098960"/>
            <a:ext cx="106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VC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48"/>
          <p:cNvSpPr/>
          <p:nvPr/>
        </p:nvSpPr>
        <p:spPr>
          <a:xfrm>
            <a:off x="749160" y="5186520"/>
            <a:ext cx="1067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Annotated VC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49"/>
          <p:cNvSpPr/>
          <p:nvPr/>
        </p:nvSpPr>
        <p:spPr>
          <a:xfrm>
            <a:off x="749160" y="6181560"/>
            <a:ext cx="1067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Annotated VC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ounded Rectangle 51"/>
          <p:cNvSpPr/>
          <p:nvPr/>
        </p:nvSpPr>
        <p:spPr>
          <a:xfrm>
            <a:off x="6019920" y="1112760"/>
            <a:ext cx="2514600" cy="84636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ffff"/>
                </a:solidFill>
                <a:latin typeface="Calibri"/>
              </a:rPr>
              <a:t>Remove  deep intronic, synonymous, UTR’s, and non-frameshift indel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ounded Rectangle 52"/>
          <p:cNvSpPr/>
          <p:nvPr/>
        </p:nvSpPr>
        <p:spPr>
          <a:xfrm>
            <a:off x="6172200" y="2200320"/>
            <a:ext cx="2209680" cy="68580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ffff"/>
                </a:solidFill>
                <a:latin typeface="Calibri"/>
              </a:rPr>
              <a:t>Remove  Frequent Variants in public databases (MAF &gt;1%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ounded Rectangle 53"/>
          <p:cNvSpPr/>
          <p:nvPr/>
        </p:nvSpPr>
        <p:spPr>
          <a:xfrm>
            <a:off x="6172200" y="3129120"/>
            <a:ext cx="2209680" cy="89028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ffff"/>
                </a:solidFill>
                <a:latin typeface="Calibri"/>
              </a:rPr>
              <a:t>Remove  Frequent Variants in in-house  DBs  (MAF &gt;1%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ounded Rectangle 54"/>
          <p:cNvSpPr/>
          <p:nvPr/>
        </p:nvSpPr>
        <p:spPr>
          <a:xfrm>
            <a:off x="6019920" y="4260960"/>
            <a:ext cx="2514600" cy="66672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ffff"/>
                </a:solidFill>
                <a:latin typeface="Calibri"/>
              </a:rPr>
              <a:t>Remove  Low  Confidence (based on torrent score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ounded Rectangle 55"/>
          <p:cNvSpPr/>
          <p:nvPr/>
        </p:nvSpPr>
        <p:spPr>
          <a:xfrm>
            <a:off x="6392880" y="6400800"/>
            <a:ext cx="1836720" cy="317520"/>
          </a:xfrm>
          <a:prstGeom prst="roundRect">
            <a:avLst>
              <a:gd name="adj" fmla="val 16667"/>
            </a:avLst>
          </a:prstGeom>
          <a:solidFill>
            <a:srgbClr val="bfbfb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17375e"/>
                </a:solidFill>
                <a:latin typeface="Calibri"/>
              </a:rPr>
              <a:t>Sanger Valid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2" name="Straight Arrow Connector 57"/>
          <p:cNvCxnSpPr>
            <a:endCxn id="57" idx="0"/>
          </p:cNvCxnSpPr>
          <p:nvPr/>
        </p:nvCxnSpPr>
        <p:spPr>
          <a:xfrm>
            <a:off x="7276680" y="788760"/>
            <a:ext cx="720" cy="3243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3" name="Straight Arrow Connector 58"/>
          <p:cNvCxnSpPr/>
          <p:nvPr/>
        </p:nvCxnSpPr>
        <p:spPr>
          <a:xfrm>
            <a:off x="7238520" y="1910880"/>
            <a:ext cx="1080" cy="2818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4" name="Straight Arrow Connector 59"/>
          <p:cNvCxnSpPr/>
          <p:nvPr/>
        </p:nvCxnSpPr>
        <p:spPr>
          <a:xfrm>
            <a:off x="7238520" y="2825280"/>
            <a:ext cx="1080" cy="2818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65" name="Straight Arrow Connector 60"/>
          <p:cNvCxnSpPr/>
          <p:nvPr/>
        </p:nvCxnSpPr>
        <p:spPr>
          <a:xfrm>
            <a:off x="7238520" y="3968280"/>
            <a:ext cx="1080" cy="2818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66" name="TextBox 65"/>
          <p:cNvSpPr/>
          <p:nvPr/>
        </p:nvSpPr>
        <p:spPr>
          <a:xfrm>
            <a:off x="1164240" y="287280"/>
            <a:ext cx="248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17375e"/>
                </a:solidFill>
                <a:latin typeface="Calibri"/>
              </a:rPr>
              <a:t>Basic Analysis Workflow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7" name="Straight Arrow Connector 68"/>
          <p:cNvCxnSpPr/>
          <p:nvPr/>
        </p:nvCxnSpPr>
        <p:spPr>
          <a:xfrm>
            <a:off x="2414160" y="6056280"/>
            <a:ext cx="1080" cy="33264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68" name="TextBox 69"/>
          <p:cNvSpPr/>
          <p:nvPr/>
        </p:nvSpPr>
        <p:spPr>
          <a:xfrm>
            <a:off x="5289480" y="61920"/>
            <a:ext cx="30164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17375e"/>
                </a:solidFill>
                <a:latin typeface="Calibri"/>
              </a:rPr>
              <a:t>Variant Filtration Workflow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9" name="Straight Arrow Connector 71"/>
          <p:cNvCxnSpPr/>
          <p:nvPr/>
        </p:nvCxnSpPr>
        <p:spPr>
          <a:xfrm>
            <a:off x="7238520" y="4876920"/>
            <a:ext cx="1080" cy="4752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70" name="Straight Arrow Connector 72"/>
          <p:cNvCxnSpPr/>
          <p:nvPr/>
        </p:nvCxnSpPr>
        <p:spPr>
          <a:xfrm>
            <a:off x="7241760" y="5545080"/>
            <a:ext cx="1080" cy="7041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71" name="TextBox 73"/>
          <p:cNvSpPr/>
          <p:nvPr/>
        </p:nvSpPr>
        <p:spPr>
          <a:xfrm>
            <a:off x="4749840" y="533520"/>
            <a:ext cx="157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(~1.2K variant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74"/>
          <p:cNvSpPr/>
          <p:nvPr/>
        </p:nvSpPr>
        <p:spPr>
          <a:xfrm>
            <a:off x="4871880" y="1960560"/>
            <a:ext cx="1330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(~350 variant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75"/>
          <p:cNvSpPr/>
          <p:nvPr/>
        </p:nvSpPr>
        <p:spPr>
          <a:xfrm>
            <a:off x="4867200" y="2886120"/>
            <a:ext cx="133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(~80 variant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83"/>
          <p:cNvSpPr/>
          <p:nvPr/>
        </p:nvSpPr>
        <p:spPr>
          <a:xfrm>
            <a:off x="4867200" y="3968640"/>
            <a:ext cx="133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(~50 variant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84"/>
          <p:cNvSpPr/>
          <p:nvPr/>
        </p:nvSpPr>
        <p:spPr>
          <a:xfrm>
            <a:off x="4867200" y="4973760"/>
            <a:ext cx="133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(~20 variant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86"/>
          <p:cNvSpPr/>
          <p:nvPr/>
        </p:nvSpPr>
        <p:spPr>
          <a:xfrm>
            <a:off x="4867200" y="5791320"/>
            <a:ext cx="133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54061"/>
                </a:solidFill>
                <a:latin typeface="Calibri"/>
              </a:rPr>
              <a:t>(1-2 variant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" name="Picture 5" descr="https://encrypted-tbn3.gstatic.com/images?q=tbn:ANd9GcQId_qVPEbg0Zs6rIxZqydJkn3WdZOuw8ig5WUl-OsLvmNjU6UP"/>
          <p:cNvPicPr/>
          <p:nvPr/>
        </p:nvPicPr>
        <p:blipFill>
          <a:blip r:embed="rId1"/>
          <a:stretch/>
        </p:blipFill>
        <p:spPr>
          <a:xfrm>
            <a:off x="5284800" y="1073160"/>
            <a:ext cx="506520" cy="50004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5" descr="https://encrypted-tbn3.gstatic.com/images?q=tbn:ANd9GcQId_qVPEbg0Zs6rIxZqydJkn3WdZOuw8ig5WUl-OsLvmNjU6UP"/>
          <p:cNvPicPr/>
          <p:nvPr/>
        </p:nvPicPr>
        <p:blipFill>
          <a:blip r:embed="rId2"/>
          <a:stretch/>
        </p:blipFill>
        <p:spPr>
          <a:xfrm>
            <a:off x="5364000" y="2292480"/>
            <a:ext cx="341640" cy="34128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5" descr="https://encrypted-tbn3.gstatic.com/images?q=tbn:ANd9GcQId_qVPEbg0Zs6rIxZqydJkn3WdZOuw8ig5WUl-OsLvmNjU6UP"/>
          <p:cNvPicPr/>
          <p:nvPr/>
        </p:nvPicPr>
        <p:blipFill>
          <a:blip r:embed="rId3"/>
          <a:stretch/>
        </p:blipFill>
        <p:spPr>
          <a:xfrm>
            <a:off x="5321160" y="3206880"/>
            <a:ext cx="427320" cy="42048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5" descr="https://encrypted-tbn3.gstatic.com/images?q=tbn:ANd9GcQId_qVPEbg0Zs6rIxZqydJkn3WdZOuw8ig5WUl-OsLvmNjU6UP"/>
          <p:cNvPicPr/>
          <p:nvPr/>
        </p:nvPicPr>
        <p:blipFill>
          <a:blip r:embed="rId4"/>
          <a:stretch/>
        </p:blipFill>
        <p:spPr>
          <a:xfrm>
            <a:off x="5357880" y="4273560"/>
            <a:ext cx="360360" cy="35892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5" descr="https://encrypted-tbn3.gstatic.com/images?q=tbn:ANd9GcQId_qVPEbg0Zs6rIxZqydJkn3WdZOuw8ig5WUl-OsLvmNjU6UP"/>
          <p:cNvPicPr/>
          <p:nvPr/>
        </p:nvPicPr>
        <p:blipFill>
          <a:blip r:embed="rId5"/>
          <a:stretch/>
        </p:blipFill>
        <p:spPr>
          <a:xfrm>
            <a:off x="5413320" y="5486400"/>
            <a:ext cx="249120" cy="249120"/>
          </a:xfrm>
          <a:prstGeom prst="rect">
            <a:avLst/>
          </a:prstGeom>
          <a:ln w="0">
            <a:noFill/>
          </a:ln>
        </p:spPr>
      </p:pic>
      <p:sp>
        <p:nvSpPr>
          <p:cNvPr id="82" name="Rounded Rectangle 70"/>
          <p:cNvSpPr/>
          <p:nvPr/>
        </p:nvSpPr>
        <p:spPr>
          <a:xfrm>
            <a:off x="6324480" y="5364000"/>
            <a:ext cx="1836720" cy="427320"/>
          </a:xfrm>
          <a:prstGeom prst="roundRect">
            <a:avLst>
              <a:gd name="adj" fmla="val 16667"/>
            </a:avLst>
          </a:prstGeom>
          <a:solidFill>
            <a:srgbClr val="bfbfb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17375e"/>
                </a:solidFill>
                <a:latin typeface="Calibri"/>
              </a:rPr>
              <a:t>Expert Evalu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user</dc:creator>
  <dc:description/>
  <dc:language>en-US</dc:language>
  <cp:lastModifiedBy>Fowzan Alkuraya</cp:lastModifiedBy>
  <dcterms:modified xsi:type="dcterms:W3CDTF">2015-06-11T12:51:26Z</dcterms:modified>
  <cp:revision>12</cp:revision>
  <dc:subject/>
  <dc:title>PowerPoint Presentation</dc:title>
</cp:coreProperties>
</file>